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1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7087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3882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0355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7042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149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5697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1345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5574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7611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494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9962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0ACBC-81CE-40A2-B6B0-AF3DD45BC305}" type="datetimeFigureOut">
              <a:rPr lang="de-DE" smtClean="0"/>
              <a:t>22.09.201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48696-21F7-4047-BAC8-FEE6DEACC04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7514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4885209"/>
              </p:ext>
            </p:extLst>
          </p:nvPr>
        </p:nvGraphicFramePr>
        <p:xfrm>
          <a:off x="165661" y="181224"/>
          <a:ext cx="8424936" cy="62264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SPW 11.0 Graph" r:id="rId3" imgW="8176320" imgH="8889480" progId="SigmaPlotGraphicObject.10">
                  <p:embed/>
                </p:oleObj>
              </mc:Choice>
              <mc:Fallback>
                <p:oleObj name="SPW 11.0 Graph" r:id="rId3" imgW="8176320" imgH="8889480" progId="SigmaPlotGraphicObject.1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5661" y="181224"/>
                        <a:ext cx="8424936" cy="62264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835696" y="188640"/>
            <a:ext cx="1008112" cy="4320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Rectangle 7"/>
          <p:cNvSpPr/>
          <p:nvPr/>
        </p:nvSpPr>
        <p:spPr>
          <a:xfrm>
            <a:off x="2123728" y="5343878"/>
            <a:ext cx="5976664" cy="457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0.6                          0.8                        1.0                         1.2                         1.4</a:t>
            </a:r>
            <a:endParaRPr lang="de-DE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1599621"/>
              </p:ext>
            </p:extLst>
          </p:nvPr>
        </p:nvGraphicFramePr>
        <p:xfrm>
          <a:off x="1871700" y="410556"/>
          <a:ext cx="1944216" cy="4630162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694363"/>
                <a:gridCol w="1249853"/>
              </a:tblGrid>
              <a:tr h="57017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200" b="1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b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I Score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b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± SD </a:t>
                      </a:r>
                    </a:p>
                  </a:txBody>
                  <a:tcPr marL="44450" marR="44450" marT="0" marB="0" anchor="b"/>
                </a:tc>
              </a:tr>
              <a:tr h="50405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284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1 ±0.92</a:t>
                      </a: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  <a:tr h="43204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417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3±1.08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  <a:tr h="43204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319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2±1.07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  <a:tr h="50405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608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3±0.97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  <a:tr h="43204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225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7±1.12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  <a:tr h="43204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293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0±0.94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  <a:tr h="504056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17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4±1.07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  <a:tr h="432048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794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0±1.07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  <a:tr h="387582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480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8±1.13</a:t>
                      </a:r>
                      <a:endParaRPr lang="de-DE" sz="1200" dirty="0">
                        <a:effectLst/>
                        <a:latin typeface="Times New Roman" panose="02020603050405020304" pitchFamily="18" charset="0"/>
                        <a:ea typeface="Calibri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</a:tr>
            </a:tbl>
          </a:graphicData>
        </a:graphic>
      </p:graphicFrame>
      <p:sp>
        <p:nvSpPr>
          <p:cNvPr id="11" name="Rectangle 10"/>
          <p:cNvSpPr/>
          <p:nvPr/>
        </p:nvSpPr>
        <p:spPr>
          <a:xfrm>
            <a:off x="611560" y="476672"/>
            <a:ext cx="1224136" cy="4303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2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untry</a:t>
            </a:r>
            <a:endParaRPr lang="de-DE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79512" y="5949280"/>
            <a:ext cx="88924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ltivariable-adjusted Hazard Ratios of the Association between HLI and Colorectal Cancer  across EPIC participating countries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508104" y="489158"/>
            <a:ext cx="23999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de-DE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difference by country = 0.17</a:t>
            </a: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9094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SPW 11.0 Graph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andart</dc:creator>
  <cp:lastModifiedBy>Standart</cp:lastModifiedBy>
  <cp:revision>7</cp:revision>
  <dcterms:created xsi:type="dcterms:W3CDTF">2014-08-13T12:25:31Z</dcterms:created>
  <dcterms:modified xsi:type="dcterms:W3CDTF">2014-09-22T14:17:43Z</dcterms:modified>
</cp:coreProperties>
</file>